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pct" ContentType="image/x-pict"/>
  <Override PartName="/ppt/media/image2.pct" ContentType="image/x-pict"/>
  <Override PartName="/ppt/media/image3.jpeg" ContentType="image/jpeg"/>
  <Override PartName="/ppt/media/image4.jpeg" ContentType="image/jpeg"/>
  <Override PartName="/ppt/media/image5.pct" ContentType="image/x-pict"/>
  <Override PartName="/ppt/media/image6.pct" ContentType="image/x-pict"/>
  <Override PartName="/ppt/media/image7.pct" ContentType="image/x-pi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70B020-AF47-4918-8709-C6492B97982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5E16C2-1917-43F5-B9ED-33B176C326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9F0066-3C84-4976-96A9-5EDF6BCA7EC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434C3A-381B-4662-80B4-26960A4E29E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967B10-40FC-4BBB-9723-4739831D4B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3CBA9D-1C21-428E-8A9F-B58061A183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08180C-6240-476D-A658-A46AD361F5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09FF2B-DD1B-4C18-9116-E04DEC1B9D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201069-0FB4-4CFD-B3A8-1412C33331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C86E4C-5F0B-410E-AB5D-0DA2B09232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F8E59A-CE33-40F5-8DBA-ADF4162F5C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4691F2-1742-48A8-8F28-F0639B6C68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A58C303-CFA1-4505-92E0-D2429DB2523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ct"/><Relationship Id="rId3" Type="http://schemas.openxmlformats.org/officeDocument/2006/relationships/package" Target="../embeddings/oleObject2.xlsx"/><Relationship Id="rId4" Type="http://schemas.openxmlformats.org/officeDocument/2006/relationships/image" Target="../media/image2.pct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4.jpe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5.pct"/><Relationship Id="rId3" Type="http://schemas.openxmlformats.org/officeDocument/2006/relationships/package" Target="../embeddings/oleObject2.xlsx"/><Relationship Id="rId4" Type="http://schemas.openxmlformats.org/officeDocument/2006/relationships/image" Target="../media/image6.pct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7.pct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57200" y="2057400"/>
          <a:ext cx="3562200" cy="43434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57200" y="2057400"/>
                    <a:ext cx="3562200" cy="4343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4952880" y="2057400"/>
          <a:ext cx="3448080" cy="43308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952880" y="2057400"/>
                    <a:ext cx="3448080" cy="4330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"/>
          <p:cNvSpPr/>
          <p:nvPr/>
        </p:nvSpPr>
        <p:spPr>
          <a:xfrm>
            <a:off x="457200" y="838080"/>
            <a:ext cx="3962520" cy="85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verage G(x) value at each position in promoters, coding regions and randomized sequences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952880" y="762120"/>
            <a:ext cx="3733920" cy="119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hannon entropy in promoter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 slight decrease is evident in the -10 regions.  There is more fluctuation here because the set of promoters is smalle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514600" y="228600"/>
            <a:ext cx="49528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Bacillus subtilis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data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609480" y="1828800"/>
            <a:ext cx="3660840" cy="434340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2"/>
          <a:stretch/>
        </p:blipFill>
        <p:spPr>
          <a:xfrm>
            <a:off x="4648320" y="1981080"/>
            <a:ext cx="4114800" cy="419112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1676520" y="297000"/>
            <a:ext cx="5410080" cy="87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Bacillus subtilis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Data 2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IDD properties of promoter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914400" y="1600200"/>
            <a:ext cx="335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mmation parameter </a:t>
            </a: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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638680" y="1600200"/>
            <a:ext cx="236232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i="1" lang="en-US" sz="1800" spc="-1" strike="noStrike" baseline="-25000">
                <a:solidFill>
                  <a:srgbClr val="000000"/>
                </a:solidFill>
                <a:latin typeface="Arial"/>
              </a:rPr>
              <a:t>m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amet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3" name=""/>
          <p:cNvGraphicFramePr/>
          <p:nvPr/>
        </p:nvGraphicFramePr>
        <p:xfrm>
          <a:off x="533520" y="1371600"/>
          <a:ext cx="4070160" cy="52513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5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33520" y="1371600"/>
                    <a:ext cx="4070160" cy="5251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5" name=""/>
          <p:cNvGraphicFramePr/>
          <p:nvPr/>
        </p:nvGraphicFramePr>
        <p:xfrm>
          <a:off x="5105520" y="1447920"/>
          <a:ext cx="3537000" cy="51750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56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105520" y="1447920"/>
                    <a:ext cx="3537000" cy="5175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7" name=""/>
          <p:cNvSpPr/>
          <p:nvPr/>
        </p:nvSpPr>
        <p:spPr>
          <a:xfrm>
            <a:off x="2286000" y="152280"/>
            <a:ext cx="5029200" cy="87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Bacillus subtilis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Data 3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nsitivity vs specificit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8" name=""/>
          <p:cNvGraphicFramePr/>
          <p:nvPr/>
        </p:nvGraphicFramePr>
        <p:xfrm>
          <a:off x="609480" y="1219320"/>
          <a:ext cx="7988400" cy="53020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5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09480" y="1219320"/>
                    <a:ext cx="7988400" cy="5302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0" name=""/>
          <p:cNvSpPr/>
          <p:nvPr/>
        </p:nvSpPr>
        <p:spPr>
          <a:xfrm>
            <a:off x="685800" y="457200"/>
            <a:ext cx="8153280" cy="51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nsitivity vs specificity for the </a:t>
            </a: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i="1" lang="en-US" sz="2400" spc="-1" strike="noStrike" baseline="-25000">
                <a:solidFill>
                  <a:srgbClr val="000000"/>
                </a:solidFill>
                <a:latin typeface="Arial"/>
              </a:rPr>
              <a:t>m 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parameter in </a:t>
            </a: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E. coli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1-10T23:42:01Z</dcterms:created>
  <dc:creator>hwang</dc:creator>
  <dc:description/>
  <dc:language>en-US</dc:language>
  <cp:lastModifiedBy>Craig Benham</cp:lastModifiedBy>
  <dcterms:modified xsi:type="dcterms:W3CDTF">2006-01-12T00:20:31Z</dcterms:modified>
  <cp:revision>4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-422529185</vt:r8>
  </property>
  <property fmtid="{D5CDD505-2E9C-101B-9397-08002B2CF9AE}" pid="3" name="_AuthorEmail">
    <vt:lpwstr>hqwang@ucdavis.edu</vt:lpwstr>
  </property>
  <property fmtid="{D5CDD505-2E9C-101B-9397-08002B2CF9AE}" pid="4" name="_AuthorEmailDisplayName">
    <vt:lpwstr>Huiquan Wang</vt:lpwstr>
  </property>
  <property fmtid="{D5CDD505-2E9C-101B-9397-08002B2CF9AE}" pid="5" name="_EmailSubject">
    <vt:lpwstr>corrections and supplementary figures</vt:lpwstr>
  </property>
</Properties>
</file>